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4" r:id="rId2"/>
  </p:sldIdLst>
  <p:sldSz cx="6492875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0042" autoAdjust="0"/>
    <p:restoredTop sz="94660"/>
  </p:normalViewPr>
  <p:slideViewPr>
    <p:cSldViewPr snapToGrid="0">
      <p:cViewPr varScale="1">
        <p:scale>
          <a:sx n="80" d="100"/>
          <a:sy n="80" d="100"/>
        </p:scale>
        <p:origin x="313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02EFE9-E17E-48A4-BD8A-CA79ACF7271C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3625" y="1143000"/>
            <a:ext cx="2190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0229D6-103D-4C95-91C8-A567FA2A88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0895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966" y="1496484"/>
            <a:ext cx="5518944" cy="3183467"/>
          </a:xfrm>
        </p:spPr>
        <p:txBody>
          <a:bodyPr anchor="b"/>
          <a:lstStyle>
            <a:lvl1pPr algn="ctr"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1610" y="4802717"/>
            <a:ext cx="4869656" cy="2207683"/>
          </a:xfrm>
        </p:spPr>
        <p:txBody>
          <a:bodyPr/>
          <a:lstStyle>
            <a:lvl1pPr marL="0" indent="0" algn="ctr">
              <a:buNone/>
              <a:defRPr sz="1704"/>
            </a:lvl1pPr>
            <a:lvl2pPr marL="324658" indent="0" algn="ctr">
              <a:buNone/>
              <a:defRPr sz="1420"/>
            </a:lvl2pPr>
            <a:lvl3pPr marL="649315" indent="0" algn="ctr">
              <a:buNone/>
              <a:defRPr sz="1278"/>
            </a:lvl3pPr>
            <a:lvl4pPr marL="973973" indent="0" algn="ctr">
              <a:buNone/>
              <a:defRPr sz="1136"/>
            </a:lvl4pPr>
            <a:lvl5pPr marL="1298631" indent="0" algn="ctr">
              <a:buNone/>
              <a:defRPr sz="1136"/>
            </a:lvl5pPr>
            <a:lvl6pPr marL="1623289" indent="0" algn="ctr">
              <a:buNone/>
              <a:defRPr sz="1136"/>
            </a:lvl6pPr>
            <a:lvl7pPr marL="1947946" indent="0" algn="ctr">
              <a:buNone/>
              <a:defRPr sz="1136"/>
            </a:lvl7pPr>
            <a:lvl8pPr marL="2272604" indent="0" algn="ctr">
              <a:buNone/>
              <a:defRPr sz="1136"/>
            </a:lvl8pPr>
            <a:lvl9pPr marL="2597262" indent="0" algn="ctr">
              <a:buNone/>
              <a:defRPr sz="113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400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8471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46464" y="486834"/>
            <a:ext cx="140002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6385" y="486834"/>
            <a:ext cx="4118918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155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462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3004" y="2279653"/>
            <a:ext cx="5600105" cy="3803649"/>
          </a:xfrm>
        </p:spPr>
        <p:txBody>
          <a:bodyPr anchor="b"/>
          <a:lstStyle>
            <a:lvl1pPr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3004" y="6119286"/>
            <a:ext cx="5600105" cy="2000249"/>
          </a:xfrm>
        </p:spPr>
        <p:txBody>
          <a:bodyPr/>
          <a:lstStyle>
            <a:lvl1pPr marL="0" indent="0">
              <a:buNone/>
              <a:defRPr sz="1704">
                <a:solidFill>
                  <a:schemeClr val="tx1">
                    <a:tint val="82000"/>
                  </a:schemeClr>
                </a:solidFill>
              </a:defRPr>
            </a:lvl1pPr>
            <a:lvl2pPr marL="324658" indent="0">
              <a:buNone/>
              <a:defRPr sz="1420">
                <a:solidFill>
                  <a:schemeClr val="tx1">
                    <a:tint val="82000"/>
                  </a:schemeClr>
                </a:solidFill>
              </a:defRPr>
            </a:lvl2pPr>
            <a:lvl3pPr marL="649315" indent="0">
              <a:buNone/>
              <a:defRPr sz="1278">
                <a:solidFill>
                  <a:schemeClr val="tx1">
                    <a:tint val="82000"/>
                  </a:schemeClr>
                </a:solidFill>
              </a:defRPr>
            </a:lvl3pPr>
            <a:lvl4pPr marL="973973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4pPr>
            <a:lvl5pPr marL="1298631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5pPr>
            <a:lvl6pPr marL="1623289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6pPr>
            <a:lvl7pPr marL="1947946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7pPr>
            <a:lvl8pPr marL="2272604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8pPr>
            <a:lvl9pPr marL="2597262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104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6385" y="2434167"/>
            <a:ext cx="2759472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7018" y="2434167"/>
            <a:ext cx="2759472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765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486836"/>
            <a:ext cx="560010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7232" y="2241551"/>
            <a:ext cx="2746790" cy="1098549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7232" y="3340100"/>
            <a:ext cx="2746790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7018" y="2241551"/>
            <a:ext cx="2760318" cy="1098549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7018" y="3340100"/>
            <a:ext cx="276031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638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130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942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609600"/>
            <a:ext cx="2094121" cy="2133600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60318" y="1316569"/>
            <a:ext cx="3287018" cy="6498167"/>
          </a:xfrm>
        </p:spPr>
        <p:txBody>
          <a:bodyPr/>
          <a:lstStyle>
            <a:lvl1pPr>
              <a:defRPr sz="2272"/>
            </a:lvl1pPr>
            <a:lvl2pPr>
              <a:defRPr sz="1988"/>
            </a:lvl2pPr>
            <a:lvl3pPr>
              <a:defRPr sz="1704"/>
            </a:lvl3pPr>
            <a:lvl4pPr>
              <a:defRPr sz="1420"/>
            </a:lvl4pPr>
            <a:lvl5pPr>
              <a:defRPr sz="1420"/>
            </a:lvl5pPr>
            <a:lvl6pPr>
              <a:defRPr sz="1420"/>
            </a:lvl6pPr>
            <a:lvl7pPr>
              <a:defRPr sz="1420"/>
            </a:lvl7pPr>
            <a:lvl8pPr>
              <a:defRPr sz="1420"/>
            </a:lvl8pPr>
            <a:lvl9pPr>
              <a:defRPr sz="14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2743200"/>
            <a:ext cx="2094121" cy="50821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202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609600"/>
            <a:ext cx="2094121" cy="2133600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60318" y="1316569"/>
            <a:ext cx="3287018" cy="6498167"/>
          </a:xfrm>
        </p:spPr>
        <p:txBody>
          <a:bodyPr anchor="t"/>
          <a:lstStyle>
            <a:lvl1pPr marL="0" indent="0">
              <a:buNone/>
              <a:defRPr sz="2272"/>
            </a:lvl1pPr>
            <a:lvl2pPr marL="324658" indent="0">
              <a:buNone/>
              <a:defRPr sz="1988"/>
            </a:lvl2pPr>
            <a:lvl3pPr marL="649315" indent="0">
              <a:buNone/>
              <a:defRPr sz="1704"/>
            </a:lvl3pPr>
            <a:lvl4pPr marL="973973" indent="0">
              <a:buNone/>
              <a:defRPr sz="1420"/>
            </a:lvl4pPr>
            <a:lvl5pPr marL="1298631" indent="0">
              <a:buNone/>
              <a:defRPr sz="1420"/>
            </a:lvl5pPr>
            <a:lvl6pPr marL="1623289" indent="0">
              <a:buNone/>
              <a:defRPr sz="1420"/>
            </a:lvl6pPr>
            <a:lvl7pPr marL="1947946" indent="0">
              <a:buNone/>
              <a:defRPr sz="1420"/>
            </a:lvl7pPr>
            <a:lvl8pPr marL="2272604" indent="0">
              <a:buNone/>
              <a:defRPr sz="1420"/>
            </a:lvl8pPr>
            <a:lvl9pPr marL="2597262" indent="0">
              <a:buNone/>
              <a:defRPr sz="142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2743200"/>
            <a:ext cx="2094121" cy="50821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533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6385" y="486836"/>
            <a:ext cx="560010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85" y="2434167"/>
            <a:ext cx="560010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6385" y="8475136"/>
            <a:ext cx="1460897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50765" y="8475136"/>
            <a:ext cx="219134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5593" y="8475136"/>
            <a:ext cx="1460897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140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9315" rtl="0" eaLnBrk="1" latinLnBrk="0" hangingPunct="1">
        <a:lnSpc>
          <a:spcPct val="90000"/>
        </a:lnSpc>
        <a:spcBef>
          <a:spcPct val="0"/>
        </a:spcBef>
        <a:buNone/>
        <a:defRPr sz="312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329" indent="-162329" algn="l" defTabSz="649315" rtl="0" eaLnBrk="1" latinLnBrk="0" hangingPunct="1">
        <a:lnSpc>
          <a:spcPct val="90000"/>
        </a:lnSpc>
        <a:spcBef>
          <a:spcPts val="710"/>
        </a:spcBef>
        <a:buFont typeface="Arial" panose="020B0604020202020204" pitchFamily="34" charset="0"/>
        <a:buChar char="•"/>
        <a:defRPr sz="1988" kern="1200">
          <a:solidFill>
            <a:schemeClr val="tx1"/>
          </a:solidFill>
          <a:latin typeface="+mn-lt"/>
          <a:ea typeface="+mn-ea"/>
          <a:cs typeface="+mn-cs"/>
        </a:defRPr>
      </a:lvl1pPr>
      <a:lvl2pPr marL="48698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704" kern="1200">
          <a:solidFill>
            <a:schemeClr val="tx1"/>
          </a:solidFill>
          <a:latin typeface="+mn-lt"/>
          <a:ea typeface="+mn-ea"/>
          <a:cs typeface="+mn-cs"/>
        </a:defRPr>
      </a:lvl2pPr>
      <a:lvl3pPr marL="811644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420" kern="1200">
          <a:solidFill>
            <a:schemeClr val="tx1"/>
          </a:solidFill>
          <a:latin typeface="+mn-lt"/>
          <a:ea typeface="+mn-ea"/>
          <a:cs typeface="+mn-cs"/>
        </a:defRPr>
      </a:lvl3pPr>
      <a:lvl4pPr marL="1136302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460960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78561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2110275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434933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759591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1pPr>
      <a:lvl2pPr marL="324658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2pPr>
      <a:lvl3pPr marL="649315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3pPr>
      <a:lvl4pPr marL="973973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298631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623289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1947946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272604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597262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9CD3A22-C324-A6BB-97A7-96EFD75E2894}"/>
              </a:ext>
            </a:extLst>
          </p:cNvPr>
          <p:cNvSpPr txBox="1"/>
          <p:nvPr/>
        </p:nvSpPr>
        <p:spPr>
          <a:xfrm flipH="1">
            <a:off x="333580" y="687334"/>
            <a:ext cx="281562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D2A676E-A762-E106-AFA4-C2FD1158CA74}"/>
              </a:ext>
            </a:extLst>
          </p:cNvPr>
          <p:cNvSpPr txBox="1"/>
          <p:nvPr/>
        </p:nvSpPr>
        <p:spPr>
          <a:xfrm>
            <a:off x="582035" y="4009242"/>
            <a:ext cx="7373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3C2AF7C-AED4-8D76-BE54-AF8332059511}"/>
              </a:ext>
            </a:extLst>
          </p:cNvPr>
          <p:cNvSpPr txBox="1"/>
          <p:nvPr/>
        </p:nvSpPr>
        <p:spPr>
          <a:xfrm>
            <a:off x="206872" y="7883150"/>
            <a:ext cx="6334286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1. </a:t>
            </a:r>
            <a:endParaRPr lang="en-US" sz="10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D-L1 expression in GBM cell lines</a:t>
            </a:r>
            <a:r>
              <a:rPr lang="en-US" sz="1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.</a:t>
            </a:r>
            <a:r>
              <a:rPr lang="en-US" sz="1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High levels of PD-L1 expression were observed in LN229 PD-L1 overexpressing (OE) cells (right panel) and in engineered GBM patient-derived QNS108 cells (left panel), whereas no PD-L1 expression was detected in LN229 PD-L1 knockout (KO) cells (middle panel).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B.</a:t>
            </a:r>
            <a:r>
              <a:rPr lang="en-US" sz="1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Native PD-L1 expression was detected in GBM patient-derived cell lines QNS985 and QNS986.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3667373-2E5F-75A1-1D5C-8EBB563242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3052" y="4241869"/>
            <a:ext cx="3714431" cy="364128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E33291BD-E8F3-2C6F-AA3D-B3139CF5B89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4361" y="463452"/>
            <a:ext cx="5254295" cy="35457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91928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95</TotalTime>
  <Words>79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Ulloa Navas, Maria J., Ph.D., M.S.</dc:creator>
  <cp:lastModifiedBy>Ulloa Navas, Maria J., Ph.D., M.S.</cp:lastModifiedBy>
  <cp:revision>64</cp:revision>
  <dcterms:created xsi:type="dcterms:W3CDTF">2024-09-02T16:12:58Z</dcterms:created>
  <dcterms:modified xsi:type="dcterms:W3CDTF">2024-11-22T20:04:59Z</dcterms:modified>
</cp:coreProperties>
</file>